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3" d="100"/>
          <a:sy n="83" d="100"/>
        </p:scale>
        <p:origin x="74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ADFB-C9DA-47D8-9C58-070C647D0B22}" type="datetimeFigureOut">
              <a:rPr lang="en-US" smtClean="0"/>
              <a:t>31-Jan-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3426-BAFD-4BC1-90D1-3916DF7395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46484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ADFB-C9DA-47D8-9C58-070C647D0B22}" type="datetimeFigureOut">
              <a:rPr lang="en-US" smtClean="0"/>
              <a:t>31-Jan-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3426-BAFD-4BC1-90D1-3916DF7395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835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ADFB-C9DA-47D8-9C58-070C647D0B22}" type="datetimeFigureOut">
              <a:rPr lang="en-US" smtClean="0"/>
              <a:t>31-Jan-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3426-BAFD-4BC1-90D1-3916DF7395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118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ADFB-C9DA-47D8-9C58-070C647D0B22}" type="datetimeFigureOut">
              <a:rPr lang="en-US" smtClean="0"/>
              <a:t>31-Jan-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3426-BAFD-4BC1-90D1-3916DF7395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709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ADFB-C9DA-47D8-9C58-070C647D0B22}" type="datetimeFigureOut">
              <a:rPr lang="en-US" smtClean="0"/>
              <a:t>31-Jan-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3426-BAFD-4BC1-90D1-3916DF7395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053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ADFB-C9DA-47D8-9C58-070C647D0B22}" type="datetimeFigureOut">
              <a:rPr lang="en-US" smtClean="0"/>
              <a:t>31-Jan-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3426-BAFD-4BC1-90D1-3916DF7395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697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ADFB-C9DA-47D8-9C58-070C647D0B22}" type="datetimeFigureOut">
              <a:rPr lang="en-US" smtClean="0"/>
              <a:t>31-Jan-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3426-BAFD-4BC1-90D1-3916DF7395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202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ADFB-C9DA-47D8-9C58-070C647D0B22}" type="datetimeFigureOut">
              <a:rPr lang="en-US" smtClean="0"/>
              <a:t>31-Jan-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3426-BAFD-4BC1-90D1-3916DF7395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201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ADFB-C9DA-47D8-9C58-070C647D0B22}" type="datetimeFigureOut">
              <a:rPr lang="en-US" smtClean="0"/>
              <a:t>31-Jan-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3426-BAFD-4BC1-90D1-3916DF7395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291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ADFB-C9DA-47D8-9C58-070C647D0B22}" type="datetimeFigureOut">
              <a:rPr lang="en-US" smtClean="0"/>
              <a:t>31-Jan-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3426-BAFD-4BC1-90D1-3916DF7395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045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ADFB-C9DA-47D8-9C58-070C647D0B22}" type="datetimeFigureOut">
              <a:rPr lang="en-US" smtClean="0"/>
              <a:t>31-Jan-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D3426-BAFD-4BC1-90D1-3916DF7395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956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4AADFB-C9DA-47D8-9C58-070C647D0B22}" type="datetimeFigureOut">
              <a:rPr lang="en-US" smtClean="0"/>
              <a:t>31-Jan-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CD3426-BAFD-4BC1-90D1-3916DF7395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7623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aasaimugam@gmail.com" TargetMode="External"/><Relationship Id="rId2" Type="http://schemas.openxmlformats.org/officeDocument/2006/relationships/hyperlink" Target="mailto:anandjavee@gmail.com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698959"/>
            <a:ext cx="11655705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rgeted metabolomic and biochemical changes during nitrogen stress mediated lipid accumulation in </a:t>
            </a:r>
            <a:r>
              <a:rPr lang="en-GB" sz="1200" b="1" i="1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enedesmus</a:t>
            </a:r>
            <a:r>
              <a:rPr lang="en-GB" sz="1200" b="1" i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i="1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uadricauda</a:t>
            </a:r>
            <a:r>
              <a:rPr lang="en-GB" sz="1200" b="1" i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SA CC202</a:t>
            </a:r>
            <a:endParaRPr lang="en-US" sz="12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2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en-IN" sz="1200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jitha</a:t>
            </a:r>
            <a:r>
              <a:rPr lang="en-IN" sz="12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lakrishnan</a:t>
            </a:r>
            <a:r>
              <a:rPr lang="en-IN" sz="12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ulochana</a:t>
            </a:r>
            <a:r>
              <a:rPr lang="en-IN" sz="1200" baseline="300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2 </a:t>
            </a:r>
            <a:r>
              <a:rPr lang="en-IN" sz="12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IN" sz="1200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uthu</a:t>
            </a:r>
            <a:r>
              <a:rPr lang="en-IN" sz="12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rumugam</a:t>
            </a:r>
            <a:r>
              <a:rPr lang="en-IN" sz="1200" baseline="300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2*</a:t>
            </a:r>
            <a:endParaRPr lang="en-US" sz="12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7150" marR="0" indent="-57150" algn="ctr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IN" sz="1200" b="1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IN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robial Processes and Technology Division, CSIR-National Institute for Interdisciplinary Science and Technology, Industrial Estate P.O., Trivandrum 695019, India</a:t>
            </a:r>
            <a:endParaRPr lang="en-US" sz="12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en-IN" sz="1200" b="1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cademy of Scientific and Innovative Research (</a:t>
            </a:r>
            <a:r>
              <a:rPr lang="en-IN" sz="12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SIR</a:t>
            </a:r>
            <a:r>
              <a:rPr lang="en-IN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Ghaziabad, India</a:t>
            </a:r>
            <a:endParaRPr lang="en-US" sz="1200" dirty="0" smtClean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en-IN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Corresponding Author: Senior Scientist, CSIR-NIIST, </a:t>
            </a:r>
            <a:r>
              <a:rPr lang="en-I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l: +91-471-2515 424; Fax: +91-471-2491 712, Email ID</a:t>
            </a:r>
            <a:r>
              <a:rPr lang="en-IN" sz="1200" b="1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IN" sz="1200" i="1" dirty="0">
                <a:solidFill>
                  <a:srgbClr val="0000FF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arumugam@niist.res.in;</a:t>
            </a:r>
            <a:r>
              <a:rPr lang="en-IN" sz="1200" dirty="0" smtClean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i="1" dirty="0">
                <a:solidFill>
                  <a:srgbClr val="0000FF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aasaimugam@gmail.com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96770" y="335666"/>
            <a:ext cx="2338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s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94017" y="3020758"/>
            <a:ext cx="5261304" cy="1835055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2604305" y="5016932"/>
            <a:ext cx="6643868" cy="3046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IN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 S1: </a:t>
            </a:r>
            <a:r>
              <a:rPr lang="en-IN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roscopic images of a; control (N</a:t>
            </a:r>
            <a:r>
              <a:rPr lang="en-IN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IN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b; nitrogen </a:t>
            </a:r>
            <a:r>
              <a:rPr lang="en-IN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arved  </a:t>
            </a:r>
            <a:r>
              <a:rPr lang="en-IN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N</a:t>
            </a:r>
            <a:r>
              <a:rPr lang="en-IN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IN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IN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IN" sz="12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adricauda</a:t>
            </a:r>
            <a:r>
              <a:rPr lang="en-IN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409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2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</cp:revision>
  <dcterms:created xsi:type="dcterms:W3CDTF">2020-01-31T11:11:53Z</dcterms:created>
  <dcterms:modified xsi:type="dcterms:W3CDTF">2020-01-31T11:13:55Z</dcterms:modified>
</cp:coreProperties>
</file>